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9" d="100"/>
          <a:sy n="99" d="100"/>
        </p:scale>
        <p:origin x="50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ianne Campbell" userId="221e60a4-dfd8-4552-88b6-64bd2a28d228" providerId="ADAL" clId="{2DD65F38-1932-4222-A1CE-E300EB768F03}"/>
    <pc:docChg chg="modSld">
      <pc:chgData name="Dianne Campbell" userId="221e60a4-dfd8-4552-88b6-64bd2a28d228" providerId="ADAL" clId="{2DD65F38-1932-4222-A1CE-E300EB768F03}" dt="2022-07-07T06:18:03.175" v="20" actId="1076"/>
      <pc:docMkLst>
        <pc:docMk/>
      </pc:docMkLst>
      <pc:sldChg chg="modSp mod">
        <pc:chgData name="Dianne Campbell" userId="221e60a4-dfd8-4552-88b6-64bd2a28d228" providerId="ADAL" clId="{2DD65F38-1932-4222-A1CE-E300EB768F03}" dt="2022-07-07T06:18:03.175" v="20" actId="1076"/>
        <pc:sldMkLst>
          <pc:docMk/>
          <pc:sldMk cId="1577407894" sldId="258"/>
        </pc:sldMkLst>
        <pc:spChg chg="mod">
          <ac:chgData name="Dianne Campbell" userId="221e60a4-dfd8-4552-88b6-64bd2a28d228" providerId="ADAL" clId="{2DD65F38-1932-4222-A1CE-E300EB768F03}" dt="2022-07-07T06:17:49.400" v="9" actId="14100"/>
          <ac:spMkLst>
            <pc:docMk/>
            <pc:sldMk cId="1577407894" sldId="258"/>
            <ac:spMk id="108" creationId="{8175B427-2872-4A1D-9511-16F734A8A12C}"/>
          </ac:spMkLst>
        </pc:spChg>
        <pc:spChg chg="mod">
          <ac:chgData name="Dianne Campbell" userId="221e60a4-dfd8-4552-88b6-64bd2a28d228" providerId="ADAL" clId="{2DD65F38-1932-4222-A1CE-E300EB768F03}" dt="2022-07-07T06:18:03.175" v="20" actId="1076"/>
          <ac:spMkLst>
            <pc:docMk/>
            <pc:sldMk cId="1577407894" sldId="258"/>
            <ac:spMk id="109" creationId="{A7E430A8-F2F2-4672-A6AC-AF65AB095DF9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E7A661-AA47-46F1-9CEC-0D20072DBD8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CD9636D-4B4E-4722-A154-F6B421912E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A19402-EFC4-4E80-B11E-2FF2DD920C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3E5FA5-82BA-4675-96EF-01BD6DF147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9F2D14-59E3-4F97-A0A7-EE3111D94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1556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C030C9-467C-4243-A87D-53EB52DCC8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8A1297B-28B4-4B28-BA06-4C99E4EB16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C96439-E4B1-40B0-82E7-AB45D6FE5C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8304A1-215D-452C-92BF-E349EABADB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1A2463-D669-4F87-82D3-9A0EADC233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339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7F43255-A226-4D3E-B266-1B443C28089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166A868-13D4-4160-9EA3-E208E54F7E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169FB2-8389-4E93-9287-8DF5DE577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66C2D6-6A4A-41CF-9EAB-52147664A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FF5020-19B7-4ABD-A426-DF9AD9AD06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909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CFEE1D-7A02-4DF0-889E-79E454F52D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2C5DB7-0A20-4815-813E-13A7BC9E88F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A20188-9052-4528-8085-181651D7A9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DA622D-C89D-4EEF-953B-15199CB52F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E56D31-5E2E-4CD6-92A2-0F82AA5E57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492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61C1F0-E0D3-41E8-8C69-349A732781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2D18D9-BCBB-4D4E-90BE-EF6CB93E14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FE2E84-B4D1-4874-9F48-7416C57A22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223461-0D10-4D25-9C82-F1FF78F1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B0A505-F95B-49CF-993D-B99046A425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84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2952F3-DF75-4B1B-95A4-19E0D7397B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9708E1-3CAD-4D57-84ED-A90A29F797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FE1999-8389-4426-B7A6-3EE810FBFF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7EE784-4888-45CC-9F21-0993ECB5D4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417D05-69AE-41B3-8E1D-664518467B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AE7BF6-FC43-4520-A918-267A7800D2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2223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23067E-78A2-45AF-9EA9-0071B61792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B2BB6F-0082-40FD-A012-9577A55BB6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B471E41-DA37-4847-84B6-81AEFA78F0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B27CC91-D0C4-4028-AF99-D0E86FDB05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8A1C5DD-C790-4734-9FEA-087EFC2F03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EF690AB-E8B4-469F-9E4E-997C3E38E3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57CBAC5-CD9A-4544-B8B1-3316E300AB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A8E03E4-79D8-41AC-9F62-93DC1668A0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732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D7F7B5-1F31-4170-B48F-5EEAC0B91F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9C73330-51BC-4169-A4A3-E8C3A9820F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A81C04D-A678-4B7A-BB20-C7AA29C0EE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7255271-FABA-4081-88F3-0ED0B77010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866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0564539-DA8C-4F29-B3C9-BADA85AF7C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3F40545-EFAC-4CD0-96E8-9F84E83012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743A729-5CC0-47E3-A5D8-35CBDF2007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478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3AE978-A111-419C-BD5B-03C86ED4C6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7DF7A1-BEE7-445B-A34A-6228FBBD09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6C5B95-D718-4C8A-ACF8-6B66738109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7C59AC-76B2-46E2-B53C-6EBA05A0DC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4F3146-AD69-4F69-A3D5-CFD5A46255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1BDC1E-A3FE-41BA-9C97-F036000F83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065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1568BF-84AB-44EA-9893-C86C34C4E8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6D928C5-E879-4576-88D8-B9DEF805D9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432414-199D-46EA-9394-940B3AF8E7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C870B8-C784-4241-A83E-D78D9C5C57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96ED6E-6143-4D2D-93DA-D913208A69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1A0DDC-FBA1-437C-9F77-F168E7FC79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61609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E918A5F-5A97-4B6D-B687-77C1C0C9CA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A9B010-4A5C-46C6-8B2B-A982F39060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76EBC2-C018-4B40-B328-D9FFFECCDAB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FBA058-E992-4CBA-9CB4-6EEE645B641B}" type="datetimeFigureOut">
              <a:rPr lang="en-US" smtClean="0"/>
              <a:t>07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A37E86-B462-49EB-B163-BEF8DEEAEA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731D1B-D21D-4594-A368-3BA62078C2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DC88CD-D88A-4C7B-8045-B0E11DD649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46628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BBBE3366-709C-4FBB-8A6F-4BA05D3364BE}"/>
              </a:ext>
            </a:extLst>
          </p:cNvPr>
          <p:cNvSpPr/>
          <p:nvPr/>
        </p:nvSpPr>
        <p:spPr>
          <a:xfrm>
            <a:off x="0" y="2847"/>
            <a:ext cx="6096000" cy="375552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150000"/>
              </a:lnSpc>
            </a:pPr>
            <a:r>
              <a:rPr lang="en-US" sz="1400" b="1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Figure E1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8B948199-F378-4B0E-9B74-CC746DAB1154}"/>
              </a:ext>
            </a:extLst>
          </p:cNvPr>
          <p:cNvGrpSpPr/>
          <p:nvPr/>
        </p:nvGrpSpPr>
        <p:grpSpPr>
          <a:xfrm>
            <a:off x="535306" y="788322"/>
            <a:ext cx="11185457" cy="5746414"/>
            <a:chOff x="535306" y="788322"/>
            <a:chExt cx="11185457" cy="5746414"/>
          </a:xfrm>
        </p:grpSpPr>
        <p:sp>
          <p:nvSpPr>
            <p:cNvPr id="6" name="Arrow: Pentagon 5">
              <a:extLst>
                <a:ext uri="{FF2B5EF4-FFF2-40B4-BE49-F238E27FC236}">
                  <a16:creationId xmlns:a16="http://schemas.microsoft.com/office/drawing/2014/main" id="{99F86DD7-C7FF-4FB4-B346-792DE9C51A4B}"/>
                </a:ext>
              </a:extLst>
            </p:cNvPr>
            <p:cNvSpPr/>
            <p:nvPr/>
          </p:nvSpPr>
          <p:spPr>
            <a:xfrm>
              <a:off x="612558" y="1165860"/>
              <a:ext cx="3258105" cy="1540509"/>
            </a:xfrm>
            <a:prstGeom prst="homePlat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dirty="0"/>
                <a:t>356 peanut-allergic children</a:t>
              </a:r>
            </a:p>
            <a:p>
              <a:r>
                <a:rPr lang="en-US" dirty="0"/>
                <a:t>31 centers in US, Canada, Australia, Germany, and Ireland</a:t>
              </a:r>
            </a:p>
          </p:txBody>
        </p:sp>
        <p:sp>
          <p:nvSpPr>
            <p:cNvPr id="7" name="Arrow: Pentagon 6">
              <a:extLst>
                <a:ext uri="{FF2B5EF4-FFF2-40B4-BE49-F238E27FC236}">
                  <a16:creationId xmlns:a16="http://schemas.microsoft.com/office/drawing/2014/main" id="{E29567C0-FA0D-4FF7-A5BD-B06DDD6B17FD}"/>
                </a:ext>
              </a:extLst>
            </p:cNvPr>
            <p:cNvSpPr/>
            <p:nvPr/>
          </p:nvSpPr>
          <p:spPr>
            <a:xfrm>
              <a:off x="612559" y="4082090"/>
              <a:ext cx="3258105" cy="1540509"/>
            </a:xfrm>
            <a:prstGeom prst="homePlat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dirty="0"/>
                <a:t>393 peanut-allergic children </a:t>
              </a:r>
            </a:p>
            <a:p>
              <a:r>
                <a:rPr lang="en-US" dirty="0"/>
                <a:t>32 centers in North America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DF40C5F-C533-4FB2-80B1-0549D34DE711}"/>
                </a:ext>
              </a:extLst>
            </p:cNvPr>
            <p:cNvSpPr txBox="1"/>
            <p:nvPr/>
          </p:nvSpPr>
          <p:spPr>
            <a:xfrm>
              <a:off x="3870663" y="1342165"/>
              <a:ext cx="301139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Randomization 2:1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D963057-32FC-4A83-B576-7536263CBD97}"/>
                </a:ext>
              </a:extLst>
            </p:cNvPr>
            <p:cNvSpPr txBox="1"/>
            <p:nvPr/>
          </p:nvSpPr>
          <p:spPr>
            <a:xfrm>
              <a:off x="3870663" y="4282551"/>
              <a:ext cx="301139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Randomization 3:1</a:t>
              </a: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9D7D4550-AB74-4C5E-B69E-1844FBC849A2}"/>
                </a:ext>
              </a:extLst>
            </p:cNvPr>
            <p:cNvSpPr/>
            <p:nvPr/>
          </p:nvSpPr>
          <p:spPr>
            <a:xfrm>
              <a:off x="7074567" y="1165861"/>
              <a:ext cx="4267200" cy="1540508"/>
            </a:xfrm>
            <a:prstGeom prst="rect">
              <a:avLst/>
            </a:prstGeom>
            <a:solidFill>
              <a:schemeClr val="bg1"/>
            </a:solidFill>
            <a:ln w="28575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FABE9D53-B289-4F66-8B52-DA21584F85AC}"/>
                </a:ext>
              </a:extLst>
            </p:cNvPr>
            <p:cNvSpPr/>
            <p:nvPr/>
          </p:nvSpPr>
          <p:spPr>
            <a:xfrm>
              <a:off x="7074568" y="4146444"/>
              <a:ext cx="2205790" cy="1540508"/>
            </a:xfrm>
            <a:prstGeom prst="rect">
              <a:avLst/>
            </a:prstGeom>
            <a:solidFill>
              <a:schemeClr val="bg1"/>
            </a:solidFill>
            <a:ln w="28575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CA69CED6-1488-44F4-8753-79395D230937}"/>
                </a:ext>
              </a:extLst>
            </p:cNvPr>
            <p:cNvCxnSpPr>
              <a:stCxn id="6" idx="3"/>
            </p:cNvCxnSpPr>
            <p:nvPr/>
          </p:nvCxnSpPr>
          <p:spPr>
            <a:xfrm flipV="1">
              <a:off x="3870663" y="1936114"/>
              <a:ext cx="1856368" cy="1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DF8EDA1D-D250-454F-93E3-2CA32CFC54DB}"/>
                </a:ext>
              </a:extLst>
            </p:cNvPr>
            <p:cNvCxnSpPr/>
            <p:nvPr/>
          </p:nvCxnSpPr>
          <p:spPr>
            <a:xfrm flipV="1">
              <a:off x="3870664" y="4852344"/>
              <a:ext cx="1856368" cy="1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38D75D4D-F53C-4779-9D40-34BF3B5ADC20}"/>
                </a:ext>
              </a:extLst>
            </p:cNvPr>
            <p:cNvCxnSpPr/>
            <p:nvPr/>
          </p:nvCxnSpPr>
          <p:spPr>
            <a:xfrm flipV="1">
              <a:off x="5727031" y="1214172"/>
              <a:ext cx="1347536" cy="721942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D5DD6362-1173-43F7-B0CE-9686F98BEE03}"/>
                </a:ext>
              </a:extLst>
            </p:cNvPr>
            <p:cNvCxnSpPr/>
            <p:nvPr/>
          </p:nvCxnSpPr>
          <p:spPr>
            <a:xfrm flipV="1">
              <a:off x="5694948" y="4130402"/>
              <a:ext cx="1347536" cy="721942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804E4369-E1A3-4DB2-B068-2A7887A70FCD}"/>
                </a:ext>
              </a:extLst>
            </p:cNvPr>
            <p:cNvCxnSpPr/>
            <p:nvPr/>
          </p:nvCxnSpPr>
          <p:spPr>
            <a:xfrm>
              <a:off x="5727031" y="1936114"/>
              <a:ext cx="1315452" cy="770255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B74ED061-CE8A-4FF8-AA4C-8DE9E001B55A}"/>
                </a:ext>
              </a:extLst>
            </p:cNvPr>
            <p:cNvCxnSpPr/>
            <p:nvPr/>
          </p:nvCxnSpPr>
          <p:spPr>
            <a:xfrm>
              <a:off x="5694948" y="4852344"/>
              <a:ext cx="1315452" cy="770255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46D9C9BE-777B-47BB-8C4A-9ABBF40D8092}"/>
                </a:ext>
              </a:extLst>
            </p:cNvPr>
            <p:cNvSpPr/>
            <p:nvPr/>
          </p:nvSpPr>
          <p:spPr>
            <a:xfrm>
              <a:off x="9224209" y="5487106"/>
              <a:ext cx="208547" cy="215888"/>
            </a:xfrm>
            <a:prstGeom prst="rect">
              <a:avLst/>
            </a:prstGeom>
            <a:solidFill>
              <a:schemeClr val="accent2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A2BAF130-4E7D-47F8-84BE-7E72AAD8BD5D}"/>
                </a:ext>
              </a:extLst>
            </p:cNvPr>
            <p:cNvSpPr/>
            <p:nvPr/>
          </p:nvSpPr>
          <p:spPr>
            <a:xfrm>
              <a:off x="9135979" y="4051340"/>
              <a:ext cx="208547" cy="215888"/>
            </a:xfrm>
            <a:prstGeom prst="rect">
              <a:avLst/>
            </a:prstGeom>
            <a:solidFill>
              <a:schemeClr val="accent2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1244406A-ACD2-4FA6-A1AD-67F2836CFCBA}"/>
                </a:ext>
              </a:extLst>
            </p:cNvPr>
            <p:cNvSpPr/>
            <p:nvPr/>
          </p:nvSpPr>
          <p:spPr>
            <a:xfrm>
              <a:off x="7034458" y="6242126"/>
              <a:ext cx="208547" cy="215888"/>
            </a:xfrm>
            <a:prstGeom prst="rect">
              <a:avLst/>
            </a:prstGeom>
            <a:solidFill>
              <a:schemeClr val="accent2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923C7D45-7CE5-42F1-96E4-ADA0076BECB0}"/>
                </a:ext>
              </a:extLst>
            </p:cNvPr>
            <p:cNvSpPr txBox="1"/>
            <p:nvPr/>
          </p:nvSpPr>
          <p:spPr>
            <a:xfrm>
              <a:off x="7291137" y="6165404"/>
              <a:ext cx="170046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Safety Endpoint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5B6958F-9408-4F2C-AB49-D9AFE9060DEB}"/>
                </a:ext>
              </a:extLst>
            </p:cNvPr>
            <p:cNvSpPr txBox="1"/>
            <p:nvPr/>
          </p:nvSpPr>
          <p:spPr>
            <a:xfrm>
              <a:off x="6853981" y="5783361"/>
              <a:ext cx="5695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M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C2AB479-E4EF-43E6-B853-B8BB0591CD1C}"/>
                </a:ext>
              </a:extLst>
            </p:cNvPr>
            <p:cNvSpPr txBox="1"/>
            <p:nvPr/>
          </p:nvSpPr>
          <p:spPr>
            <a:xfrm>
              <a:off x="10962771" y="2806311"/>
              <a:ext cx="7579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M12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C07EF61-C4F8-4330-BAB2-3D6F8FCA4453}"/>
                </a:ext>
              </a:extLst>
            </p:cNvPr>
            <p:cNvSpPr txBox="1"/>
            <p:nvPr/>
          </p:nvSpPr>
          <p:spPr>
            <a:xfrm>
              <a:off x="6890077" y="2733284"/>
              <a:ext cx="5695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M0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FD104016-EB39-4BFC-8C8F-5467C6EE9F6F}"/>
                </a:ext>
              </a:extLst>
            </p:cNvPr>
            <p:cNvSpPr txBox="1"/>
            <p:nvPr/>
          </p:nvSpPr>
          <p:spPr>
            <a:xfrm>
              <a:off x="9111915" y="5783361"/>
              <a:ext cx="5695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M6</a:t>
              </a:r>
            </a:p>
          </p:txBody>
        </p:sp>
        <p:sp>
          <p:nvSpPr>
            <p:cNvPr id="33" name="Flowchart: Connector 32">
              <a:extLst>
                <a:ext uri="{FF2B5EF4-FFF2-40B4-BE49-F238E27FC236}">
                  <a16:creationId xmlns:a16="http://schemas.microsoft.com/office/drawing/2014/main" id="{4F7870C2-573B-4703-B525-2485655F2D4D}"/>
                </a:ext>
              </a:extLst>
            </p:cNvPr>
            <p:cNvSpPr/>
            <p:nvPr/>
          </p:nvSpPr>
          <p:spPr>
            <a:xfrm>
              <a:off x="6958265" y="1103896"/>
              <a:ext cx="232605" cy="226897"/>
            </a:xfrm>
            <a:prstGeom prst="flowChartConnector">
              <a:avLst/>
            </a:prstGeom>
            <a:solidFill>
              <a:schemeClr val="accent2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Flowchart: Connector 33">
              <a:extLst>
                <a:ext uri="{FF2B5EF4-FFF2-40B4-BE49-F238E27FC236}">
                  <a16:creationId xmlns:a16="http://schemas.microsoft.com/office/drawing/2014/main" id="{9B72E0FE-6806-4F9F-B7F9-A1E42CD3F948}"/>
                </a:ext>
              </a:extLst>
            </p:cNvPr>
            <p:cNvSpPr/>
            <p:nvPr/>
          </p:nvSpPr>
          <p:spPr>
            <a:xfrm>
              <a:off x="6958265" y="2559853"/>
              <a:ext cx="232605" cy="226897"/>
            </a:xfrm>
            <a:prstGeom prst="flowChartConnector">
              <a:avLst/>
            </a:prstGeom>
            <a:solidFill>
              <a:schemeClr val="accent2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Flowchart: Connector 34">
              <a:extLst>
                <a:ext uri="{FF2B5EF4-FFF2-40B4-BE49-F238E27FC236}">
                  <a16:creationId xmlns:a16="http://schemas.microsoft.com/office/drawing/2014/main" id="{7FE8FE44-D51A-4756-8451-E9F9C06C0192}"/>
                </a:ext>
              </a:extLst>
            </p:cNvPr>
            <p:cNvSpPr/>
            <p:nvPr/>
          </p:nvSpPr>
          <p:spPr>
            <a:xfrm>
              <a:off x="11257548" y="2529443"/>
              <a:ext cx="232605" cy="226897"/>
            </a:xfrm>
            <a:prstGeom prst="flowChartConnector">
              <a:avLst/>
            </a:prstGeom>
            <a:solidFill>
              <a:schemeClr val="accent2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" name="Flowchart: Connector 35">
              <a:extLst>
                <a:ext uri="{FF2B5EF4-FFF2-40B4-BE49-F238E27FC236}">
                  <a16:creationId xmlns:a16="http://schemas.microsoft.com/office/drawing/2014/main" id="{8AE5AFB1-7735-4EC8-AD89-ED6485901F68}"/>
                </a:ext>
              </a:extLst>
            </p:cNvPr>
            <p:cNvSpPr/>
            <p:nvPr/>
          </p:nvSpPr>
          <p:spPr>
            <a:xfrm>
              <a:off x="11225464" y="1065919"/>
              <a:ext cx="232605" cy="226897"/>
            </a:xfrm>
            <a:prstGeom prst="flowChartConnector">
              <a:avLst/>
            </a:prstGeom>
            <a:solidFill>
              <a:schemeClr val="accent2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Flowchart: Connector 36">
              <a:extLst>
                <a:ext uri="{FF2B5EF4-FFF2-40B4-BE49-F238E27FC236}">
                  <a16:creationId xmlns:a16="http://schemas.microsoft.com/office/drawing/2014/main" id="{44D943B2-0E1D-4C43-B1AB-C243C15C77C3}"/>
                </a:ext>
              </a:extLst>
            </p:cNvPr>
            <p:cNvSpPr/>
            <p:nvPr/>
          </p:nvSpPr>
          <p:spPr>
            <a:xfrm>
              <a:off x="6958265" y="3107528"/>
              <a:ext cx="232605" cy="226897"/>
            </a:xfrm>
            <a:prstGeom prst="flowChartConnector">
              <a:avLst/>
            </a:prstGeom>
            <a:solidFill>
              <a:schemeClr val="accent2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BCB5C3F-CB67-45D3-B25C-5FC19256C1C4}"/>
                </a:ext>
              </a:extLst>
            </p:cNvPr>
            <p:cNvSpPr txBox="1"/>
            <p:nvPr/>
          </p:nvSpPr>
          <p:spPr>
            <a:xfrm>
              <a:off x="7194875" y="3036981"/>
              <a:ext cx="28474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Denotes a DBPCFC 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47DAD179-2C42-4BBD-A8BA-CE2CA586E505}"/>
                </a:ext>
              </a:extLst>
            </p:cNvPr>
            <p:cNvSpPr txBox="1"/>
            <p:nvPr/>
          </p:nvSpPr>
          <p:spPr>
            <a:xfrm>
              <a:off x="8025059" y="788322"/>
              <a:ext cx="30439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Viaskin</a:t>
              </a:r>
              <a:r>
                <a:rPr lang="en-US" dirty="0"/>
                <a:t> Peanut  250 µg, n=238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07E8E39A-3657-46FD-AA60-45E84E398676}"/>
                </a:ext>
              </a:extLst>
            </p:cNvPr>
            <p:cNvSpPr txBox="1"/>
            <p:nvPr/>
          </p:nvSpPr>
          <p:spPr>
            <a:xfrm>
              <a:off x="8141367" y="2323096"/>
              <a:ext cx="17492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Placebo, n=118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F5C9AA8B-35D3-4FDB-810F-24DFF3EB768D}"/>
                </a:ext>
              </a:extLst>
            </p:cNvPr>
            <p:cNvSpPr txBox="1"/>
            <p:nvPr/>
          </p:nvSpPr>
          <p:spPr>
            <a:xfrm>
              <a:off x="7118682" y="5302440"/>
              <a:ext cx="171600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Placebo, n=99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D2DA42C3-E829-4592-8135-106D3C1DD965}"/>
                </a:ext>
              </a:extLst>
            </p:cNvPr>
            <p:cNvSpPr txBox="1"/>
            <p:nvPr/>
          </p:nvSpPr>
          <p:spPr>
            <a:xfrm>
              <a:off x="7118682" y="3719586"/>
              <a:ext cx="40345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Viaskin</a:t>
              </a:r>
              <a:r>
                <a:rPr lang="en-US" dirty="0"/>
                <a:t> Peanut  250 µg, n=294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8175B427-2872-4A1D-9511-16F734A8A12C}"/>
                </a:ext>
              </a:extLst>
            </p:cNvPr>
            <p:cNvSpPr txBox="1"/>
            <p:nvPr/>
          </p:nvSpPr>
          <p:spPr>
            <a:xfrm>
              <a:off x="535306" y="796528"/>
              <a:ext cx="18666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A, PEPITES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A7E430A8-F2F2-4672-A6AC-AF65AB095DF9}"/>
                </a:ext>
              </a:extLst>
            </p:cNvPr>
            <p:cNvSpPr txBox="1"/>
            <p:nvPr/>
          </p:nvSpPr>
          <p:spPr>
            <a:xfrm>
              <a:off x="535306" y="3649912"/>
              <a:ext cx="124186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B, REALIS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774078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0910E230E33434A8F72B935337CA89F" ma:contentTypeVersion="12" ma:contentTypeDescription="Create a new document." ma:contentTypeScope="" ma:versionID="b3ff08a6f125daa8ebdd740d7b02ce8d">
  <xsd:schema xmlns:xsd="http://www.w3.org/2001/XMLSchema" xmlns:xs="http://www.w3.org/2001/XMLSchema" xmlns:p="http://schemas.microsoft.com/office/2006/metadata/properties" xmlns:ns2="95734648-81ed-4cb3-86b2-a255be970428" xmlns:ns3="e2ccda8d-dc0e-4ba9-a702-5fb58a589676" targetNamespace="http://schemas.microsoft.com/office/2006/metadata/properties" ma:root="true" ma:fieldsID="a265fdcba77d5f8ff2fc6162e3c01732" ns2:_="" ns3:_="">
    <xsd:import namespace="95734648-81ed-4cb3-86b2-a255be970428"/>
    <xsd:import namespace="e2ccda8d-dc0e-4ba9-a702-5fb58a58967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EventHashCode" minOccurs="0"/>
                <xsd:element ref="ns2:MediaServiceGenerationTime" minOccurs="0"/>
                <xsd:element ref="ns2:MediaServiceAutoTags" minOccurs="0"/>
                <xsd:element ref="ns2:MediaServiceOCR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5734648-81ed-4cb3-86b2-a255be97042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Tags" ma:index="14" nillable="true" ma:displayName="MediaServiceAutoTags" ma:internalName="MediaServiceAutoTags" ma:readOnly="true">
      <xsd:simpleType>
        <xsd:restriction base="dms:Text"/>
      </xsd:simpleType>
    </xsd:element>
    <xsd:element name="MediaServiceOCR" ma:index="15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2ccda8d-dc0e-4ba9-a702-5fb58a589676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4AA79E53-8777-4502-99DF-CF71D422ABDA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F3433BC6-1560-4E8C-B129-D22DD7A991C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5734648-81ed-4cb3-86b2-a255be970428"/>
    <ds:schemaRef ds:uri="e2ccda8d-dc0e-4ba9-a702-5fb58a58967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EF64C1B8-775C-48F7-8B34-677F4762532C}">
  <ds:schemaRefs>
    <ds:schemaRef ds:uri="http://purl.org/dc/dcmitype/"/>
    <ds:schemaRef ds:uri="http://purl.org/dc/elements/1.1/"/>
    <ds:schemaRef ds:uri="http://schemas.microsoft.com/office/2006/metadata/properties"/>
    <ds:schemaRef ds:uri="http://schemas.microsoft.com/office/2006/documentManagement/types"/>
    <ds:schemaRef ds:uri="http://purl.org/dc/terms/"/>
    <ds:schemaRef ds:uri="http://www.w3.org/XML/1998/namespace"/>
    <ds:schemaRef ds:uri="http://schemas.microsoft.com/office/infopath/2007/PartnerControls"/>
    <ds:schemaRef ds:uri="http://schemas.openxmlformats.org/package/2006/metadata/core-properties"/>
    <ds:schemaRef ds:uri="1b8c0a43-fee0-4e1c-bf87-ca768e4d5fff"/>
    <ds:schemaRef ds:uri="a70e900c-8360-41e2-bb31-4c3e814607f3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1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orbidities Manuscript Figures</dc:title>
  <dc:creator>Paula Davis</dc:creator>
  <cp:lastModifiedBy>Dianne Campbell</cp:lastModifiedBy>
  <cp:revision>22</cp:revision>
  <dcterms:created xsi:type="dcterms:W3CDTF">2020-10-15T21:56:15Z</dcterms:created>
  <dcterms:modified xsi:type="dcterms:W3CDTF">2022-07-07T06:18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0910E230E33434A8F72B935337CA89F</vt:lpwstr>
  </property>
</Properties>
</file>